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25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3F5A9-3465-41EE-BD66-6547E0D8102F}" type="datetimeFigureOut">
              <a:rPr lang="it-IT" smtClean="0"/>
              <a:t>13/01/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01363-6DC1-47CE-ACB6-9E79BBB3AFC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663530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3F5A9-3465-41EE-BD66-6547E0D8102F}" type="datetimeFigureOut">
              <a:rPr lang="it-IT" smtClean="0"/>
              <a:t>13/01/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01363-6DC1-47CE-ACB6-9E79BBB3AFC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49579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3F5A9-3465-41EE-BD66-6547E0D8102F}" type="datetimeFigureOut">
              <a:rPr lang="it-IT" smtClean="0"/>
              <a:t>13/01/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01363-6DC1-47CE-ACB6-9E79BBB3AFC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421445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3F5A9-3465-41EE-BD66-6547E0D8102F}" type="datetimeFigureOut">
              <a:rPr lang="it-IT" smtClean="0"/>
              <a:t>13/01/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01363-6DC1-47CE-ACB6-9E79BBB3AFC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418294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3F5A9-3465-41EE-BD66-6547E0D8102F}" type="datetimeFigureOut">
              <a:rPr lang="it-IT" smtClean="0"/>
              <a:t>13/01/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01363-6DC1-47CE-ACB6-9E79BBB3AFC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815917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3F5A9-3465-41EE-BD66-6547E0D8102F}" type="datetimeFigureOut">
              <a:rPr lang="it-IT" smtClean="0"/>
              <a:t>13/01/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01363-6DC1-47CE-ACB6-9E79BBB3AFC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781874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3F5A9-3465-41EE-BD66-6547E0D8102F}" type="datetimeFigureOut">
              <a:rPr lang="it-IT" smtClean="0"/>
              <a:t>13/01/23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01363-6DC1-47CE-ACB6-9E79BBB3AFC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860034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3F5A9-3465-41EE-BD66-6547E0D8102F}" type="datetimeFigureOut">
              <a:rPr lang="it-IT" smtClean="0"/>
              <a:t>13/01/23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01363-6DC1-47CE-ACB6-9E79BBB3AFC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678562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3F5A9-3465-41EE-BD66-6547E0D8102F}" type="datetimeFigureOut">
              <a:rPr lang="it-IT" smtClean="0"/>
              <a:t>13/01/23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01363-6DC1-47CE-ACB6-9E79BBB3AFC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654258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3F5A9-3465-41EE-BD66-6547E0D8102F}" type="datetimeFigureOut">
              <a:rPr lang="it-IT" smtClean="0"/>
              <a:t>13/01/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01363-6DC1-47CE-ACB6-9E79BBB3AFC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734030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3F5A9-3465-41EE-BD66-6547E0D8102F}" type="datetimeFigureOut">
              <a:rPr lang="it-IT" smtClean="0"/>
              <a:t>13/01/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01363-6DC1-47CE-ACB6-9E79BBB3AFC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108774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43F5A9-3465-41EE-BD66-6547E0D8102F}" type="datetimeFigureOut">
              <a:rPr lang="it-IT" smtClean="0"/>
              <a:t>13/01/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C01363-6DC1-47CE-ACB6-9E79BBB3AFC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09190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magin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77931" y="967076"/>
            <a:ext cx="7343775" cy="307657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Rettangolo 8"/>
          <p:cNvSpPr/>
          <p:nvPr/>
        </p:nvSpPr>
        <p:spPr>
          <a:xfrm>
            <a:off x="1422400" y="4426635"/>
            <a:ext cx="9494982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S1.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: comparison between log(CPI) resulting from real fathers (dots) and log(CPI) resulting from unrelated individuals (bars); </a:t>
            </a:r>
            <a:r>
              <a:rPr lang="en-US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: comparison between log(CPI) resulting from real fathers (dots) and log(CPI) resulting from simulated full brothers (bars).</a:t>
            </a:r>
            <a:endParaRPr lang="it-IT" sz="1400" dirty="0"/>
          </a:p>
        </p:txBody>
      </p:sp>
      <p:sp>
        <p:nvSpPr>
          <p:cNvPr id="10" name="CasellaDiTesto 9"/>
          <p:cNvSpPr txBox="1"/>
          <p:nvPr/>
        </p:nvSpPr>
        <p:spPr>
          <a:xfrm>
            <a:off x="2447635" y="905170"/>
            <a:ext cx="3417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b="1" dirty="0">
                <a:latin typeface="Palatino Linotype" panose="02040502050505030304" pitchFamily="18" charset="0"/>
              </a:rPr>
              <a:t>a</a:t>
            </a:r>
          </a:p>
        </p:txBody>
      </p:sp>
      <p:sp>
        <p:nvSpPr>
          <p:cNvPr id="11" name="CasellaDiTesto 10"/>
          <p:cNvSpPr txBox="1"/>
          <p:nvPr/>
        </p:nvSpPr>
        <p:spPr>
          <a:xfrm>
            <a:off x="6109868" y="909788"/>
            <a:ext cx="3417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b="1" dirty="0">
                <a:latin typeface="Palatino Linotype" panose="0204050205050503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27860557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61</Words>
  <Application>Microsoft Macintosh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</dc:creator>
  <cp:lastModifiedBy>emiliano giardina</cp:lastModifiedBy>
  <cp:revision>2</cp:revision>
  <dcterms:created xsi:type="dcterms:W3CDTF">2022-12-20T12:02:36Z</dcterms:created>
  <dcterms:modified xsi:type="dcterms:W3CDTF">2023-01-13T15:18:43Z</dcterms:modified>
</cp:coreProperties>
</file>